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revisionInfo.xml" ContentType="application/vnd.ms-powerpoint.revisioninfo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6" r:id="rId5"/>
    <p:sldId id="260" r:id="rId6"/>
    <p:sldId id="261" r:id="rId7"/>
    <p:sldId id="264" r:id="rId8"/>
    <p:sldId id="265" r:id="rId9"/>
    <p:sldId id="266" r:id="rId1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333CC"/>
    <a:srgbClr val="FF9933"/>
    <a:srgbClr val="3399FF"/>
    <a:srgbClr val="FFCC00"/>
    <a:srgbClr val="00FFFF"/>
    <a:srgbClr val="3333FF"/>
    <a:srgbClr val="0066FF"/>
    <a:srgbClr val="0000FF"/>
    <a:srgbClr val="00FF00"/>
    <a:srgbClr val="CCEEF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8281CD4-2781-4627-B7F8-2E06C55C46EF}" v="33" dt="2021-03-16T12:58:07.966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BC89EF96-8CEA-46FF-86C4-4CE0E7609802}" styleName="Light Style 3 - Accent 1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019" autoAdjust="0"/>
    <p:restoredTop sz="94660"/>
  </p:normalViewPr>
  <p:slideViewPr>
    <p:cSldViewPr snapToGrid="0">
      <p:cViewPr varScale="1">
        <p:scale>
          <a:sx n="113" d="100"/>
          <a:sy n="113" d="100"/>
        </p:scale>
        <p:origin x="300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theme" Target="theme/theme1.xml"/><Relationship Id="rId39" Type="http://schemas.microsoft.com/office/2015/10/relationships/revisionInfo" Target="revisionInfo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presProps" Target="presProps.xml"/><Relationship Id="rId40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Eugenia Radulescu" userId="4c9b83b1-7b32-4c3b-a428-4cd3c8658a54" providerId="ADAL" clId="{E8281CD4-2781-4627-B7F8-2E06C55C46EF}"/>
    <pc:docChg chg="undo custSel modSld">
      <pc:chgData name="Eugenia Radulescu" userId="4c9b83b1-7b32-4c3b-a428-4cd3c8658a54" providerId="ADAL" clId="{E8281CD4-2781-4627-B7F8-2E06C55C46EF}" dt="2021-03-16T13:03:48.861" v="1003" actId="1038"/>
      <pc:docMkLst>
        <pc:docMk/>
      </pc:docMkLst>
      <pc:sldChg chg="addSp delSp modSp mod">
        <pc:chgData name="Eugenia Radulescu" userId="4c9b83b1-7b32-4c3b-a428-4cd3c8658a54" providerId="ADAL" clId="{E8281CD4-2781-4627-B7F8-2E06C55C46EF}" dt="2021-03-02T04:04:38.091" v="14" actId="1076"/>
        <pc:sldMkLst>
          <pc:docMk/>
          <pc:sldMk cId="2526765237" sldId="282"/>
        </pc:sldMkLst>
        <pc:picChg chg="mod">
          <ac:chgData name="Eugenia Radulescu" userId="4c9b83b1-7b32-4c3b-a428-4cd3c8658a54" providerId="ADAL" clId="{E8281CD4-2781-4627-B7F8-2E06C55C46EF}" dt="2021-03-02T04:02:04.269" v="8" actId="1076"/>
          <ac:picMkLst>
            <pc:docMk/>
            <pc:sldMk cId="2526765237" sldId="282"/>
            <ac:picMk id="3" creationId="{00000000-0000-0000-0000-000000000000}"/>
          </ac:picMkLst>
        </pc:picChg>
        <pc:picChg chg="del">
          <ac:chgData name="Eugenia Radulescu" userId="4c9b83b1-7b32-4c3b-a428-4cd3c8658a54" providerId="ADAL" clId="{E8281CD4-2781-4627-B7F8-2E06C55C46EF}" dt="2021-03-02T04:00:18.934" v="0" actId="478"/>
          <ac:picMkLst>
            <pc:docMk/>
            <pc:sldMk cId="2526765237" sldId="282"/>
            <ac:picMk id="4" creationId="{00000000-0000-0000-0000-000000000000}"/>
          </ac:picMkLst>
        </pc:picChg>
        <pc:picChg chg="add del mod modCrop">
          <ac:chgData name="Eugenia Radulescu" userId="4c9b83b1-7b32-4c3b-a428-4cd3c8658a54" providerId="ADAL" clId="{E8281CD4-2781-4627-B7F8-2E06C55C46EF}" dt="2021-03-02T04:03:06.805" v="10" actId="478"/>
          <ac:picMkLst>
            <pc:docMk/>
            <pc:sldMk cId="2526765237" sldId="282"/>
            <ac:picMk id="5" creationId="{D461188B-5B86-4D4A-9339-4224F4073938}"/>
          </ac:picMkLst>
        </pc:picChg>
        <pc:picChg chg="add mod">
          <ac:chgData name="Eugenia Radulescu" userId="4c9b83b1-7b32-4c3b-a428-4cd3c8658a54" providerId="ADAL" clId="{E8281CD4-2781-4627-B7F8-2E06C55C46EF}" dt="2021-03-02T04:04:38.091" v="14" actId="1076"/>
          <ac:picMkLst>
            <pc:docMk/>
            <pc:sldMk cId="2526765237" sldId="282"/>
            <ac:picMk id="7" creationId="{D1AD564C-C9F0-4C75-8266-9B487A336640}"/>
          </ac:picMkLst>
        </pc:picChg>
      </pc:sldChg>
      <pc:sldChg chg="addSp delSp modSp mod">
        <pc:chgData name="Eugenia Radulescu" userId="4c9b83b1-7b32-4c3b-a428-4cd3c8658a54" providerId="ADAL" clId="{E8281CD4-2781-4627-B7F8-2E06C55C46EF}" dt="2021-03-03T05:01:09.694" v="758" actId="1076"/>
        <pc:sldMkLst>
          <pc:docMk/>
          <pc:sldMk cId="1678264830" sldId="283"/>
        </pc:sldMkLst>
        <pc:spChg chg="mod">
          <ac:chgData name="Eugenia Radulescu" userId="4c9b83b1-7b32-4c3b-a428-4cd3c8658a54" providerId="ADAL" clId="{E8281CD4-2781-4627-B7F8-2E06C55C46EF}" dt="2021-03-03T04:59:17.960" v="712"/>
          <ac:spMkLst>
            <pc:docMk/>
            <pc:sldMk cId="1678264830" sldId="283"/>
            <ac:spMk id="27" creationId="{A88A2077-0655-4C40-90FF-7916CB0E8BE0}"/>
          </ac:spMkLst>
        </pc:spChg>
        <pc:grpChg chg="del mod">
          <ac:chgData name="Eugenia Radulescu" userId="4c9b83b1-7b32-4c3b-a428-4cd3c8658a54" providerId="ADAL" clId="{E8281CD4-2781-4627-B7F8-2E06C55C46EF}" dt="2021-03-03T04:36:36.143" v="210" actId="21"/>
          <ac:grpSpMkLst>
            <pc:docMk/>
            <pc:sldMk cId="1678264830" sldId="283"/>
            <ac:grpSpMk id="7" creationId="{00000000-0000-0000-0000-000000000000}"/>
          </ac:grpSpMkLst>
        </pc:grpChg>
        <pc:grpChg chg="mod">
          <ac:chgData name="Eugenia Radulescu" userId="4c9b83b1-7b32-4c3b-a428-4cd3c8658a54" providerId="ADAL" clId="{E8281CD4-2781-4627-B7F8-2E06C55C46EF}" dt="2021-03-03T05:01:09.694" v="758" actId="1076"/>
          <ac:grpSpMkLst>
            <pc:docMk/>
            <pc:sldMk cId="1678264830" sldId="283"/>
            <ac:grpSpMk id="22" creationId="{00000000-0000-0000-0000-000000000000}"/>
          </ac:grpSpMkLst>
        </pc:grpChg>
        <pc:grpChg chg="add mod">
          <ac:chgData name="Eugenia Radulescu" userId="4c9b83b1-7b32-4c3b-a428-4cd3c8658a54" providerId="ADAL" clId="{E8281CD4-2781-4627-B7F8-2E06C55C46EF}" dt="2021-03-03T04:59:24.533" v="752" actId="1036"/>
          <ac:grpSpMkLst>
            <pc:docMk/>
            <pc:sldMk cId="1678264830" sldId="283"/>
            <ac:grpSpMk id="25" creationId="{8214A7BC-BCE3-4D28-8F7A-47628B725BD8}"/>
          </ac:grpSpMkLst>
        </pc:grpChg>
        <pc:graphicFrameChg chg="add del mod ord modGraphic">
          <ac:chgData name="Eugenia Radulescu" userId="4c9b83b1-7b32-4c3b-a428-4cd3c8658a54" providerId="ADAL" clId="{E8281CD4-2781-4627-B7F8-2E06C55C46EF}" dt="2021-03-03T04:19:14.351" v="164" actId="478"/>
          <ac:graphicFrameMkLst>
            <pc:docMk/>
            <pc:sldMk cId="1678264830" sldId="283"/>
            <ac:graphicFrameMk id="2" creationId="{C709D22D-1EED-4B6D-B777-1732E440919C}"/>
          </ac:graphicFrameMkLst>
        </pc:graphicFrameChg>
        <pc:graphicFrameChg chg="add del modGraphic">
          <ac:chgData name="Eugenia Radulescu" userId="4c9b83b1-7b32-4c3b-a428-4cd3c8658a54" providerId="ADAL" clId="{E8281CD4-2781-4627-B7F8-2E06C55C46EF}" dt="2021-03-03T04:29:00.659" v="166" actId="1032"/>
          <ac:graphicFrameMkLst>
            <pc:docMk/>
            <pc:sldMk cId="1678264830" sldId="283"/>
            <ac:graphicFrameMk id="3" creationId="{80C51B97-5B1E-4F85-960B-93A40D9DD79F}"/>
          </ac:graphicFrameMkLst>
        </pc:graphicFrameChg>
        <pc:graphicFrameChg chg="add del mod">
          <ac:chgData name="Eugenia Radulescu" userId="4c9b83b1-7b32-4c3b-a428-4cd3c8658a54" providerId="ADAL" clId="{E8281CD4-2781-4627-B7F8-2E06C55C46EF}" dt="2021-03-03T04:39:37.298" v="237" actId="478"/>
          <ac:graphicFrameMkLst>
            <pc:docMk/>
            <pc:sldMk cId="1678264830" sldId="283"/>
            <ac:graphicFrameMk id="19" creationId="{51FE8D1E-75E4-403B-9D68-6F5350B3970C}"/>
          </ac:graphicFrameMkLst>
        </pc:graphicFrameChg>
        <pc:graphicFrameChg chg="add del mod">
          <ac:chgData name="Eugenia Radulescu" userId="4c9b83b1-7b32-4c3b-a428-4cd3c8658a54" providerId="ADAL" clId="{E8281CD4-2781-4627-B7F8-2E06C55C46EF}" dt="2021-03-03T04:38:32.537" v="217"/>
          <ac:graphicFrameMkLst>
            <pc:docMk/>
            <pc:sldMk cId="1678264830" sldId="283"/>
            <ac:graphicFrameMk id="23" creationId="{C067B3E0-68A4-4DB6-A6CE-CCA00DA202F4}"/>
          </ac:graphicFrameMkLst>
        </pc:graphicFrameChg>
        <pc:graphicFrameChg chg="add del mod">
          <ac:chgData name="Eugenia Radulescu" userId="4c9b83b1-7b32-4c3b-a428-4cd3c8658a54" providerId="ADAL" clId="{E8281CD4-2781-4627-B7F8-2E06C55C46EF}" dt="2021-03-03T04:38:31.888" v="216"/>
          <ac:graphicFrameMkLst>
            <pc:docMk/>
            <pc:sldMk cId="1678264830" sldId="283"/>
            <ac:graphicFrameMk id="24" creationId="{186701EB-9E39-4EFB-8064-1DE8B55789C6}"/>
          </ac:graphicFrameMkLst>
        </pc:graphicFrameChg>
        <pc:graphicFrameChg chg="del">
          <ac:chgData name="Eugenia Radulescu" userId="4c9b83b1-7b32-4c3b-a428-4cd3c8658a54" providerId="ADAL" clId="{E8281CD4-2781-4627-B7F8-2E06C55C46EF}" dt="2021-03-03T04:10:09.631" v="15" actId="478"/>
          <ac:graphicFrameMkLst>
            <pc:docMk/>
            <pc:sldMk cId="1678264830" sldId="283"/>
            <ac:graphicFrameMk id="39" creationId="{00000000-0000-0000-0000-000000000000}"/>
          </ac:graphicFrameMkLst>
        </pc:graphicFrameChg>
        <pc:picChg chg="add mod modCrop">
          <ac:chgData name="Eugenia Radulescu" userId="4c9b83b1-7b32-4c3b-a428-4cd3c8658a54" providerId="ADAL" clId="{E8281CD4-2781-4627-B7F8-2E06C55C46EF}" dt="2021-03-03T04:58:59.434" v="711" actId="14100"/>
          <ac:picMkLst>
            <pc:docMk/>
            <pc:sldMk cId="1678264830" sldId="283"/>
            <ac:picMk id="8" creationId="{AB272660-2551-4611-8507-89739CC82B70}"/>
          </ac:picMkLst>
        </pc:picChg>
        <pc:picChg chg="mod">
          <ac:chgData name="Eugenia Radulescu" userId="4c9b83b1-7b32-4c3b-a428-4cd3c8658a54" providerId="ADAL" clId="{E8281CD4-2781-4627-B7F8-2E06C55C46EF}" dt="2021-03-03T04:59:17.960" v="712"/>
          <ac:picMkLst>
            <pc:docMk/>
            <pc:sldMk cId="1678264830" sldId="283"/>
            <ac:picMk id="26" creationId="{D7197C51-9A9F-40A2-B72E-420EED0B7E18}"/>
          </ac:picMkLst>
        </pc:picChg>
        <pc:picChg chg="mod">
          <ac:chgData name="Eugenia Radulescu" userId="4c9b83b1-7b32-4c3b-a428-4cd3c8658a54" providerId="ADAL" clId="{E8281CD4-2781-4627-B7F8-2E06C55C46EF}" dt="2021-03-03T05:00:48.651" v="757" actId="1076"/>
          <ac:picMkLst>
            <pc:docMk/>
            <pc:sldMk cId="1678264830" sldId="283"/>
            <ac:picMk id="40" creationId="{00000000-0000-0000-0000-000000000000}"/>
          </ac:picMkLst>
        </pc:picChg>
      </pc:sldChg>
      <pc:sldChg chg="addSp modSp mod">
        <pc:chgData name="Eugenia Radulescu" userId="4c9b83b1-7b32-4c3b-a428-4cd3c8658a54" providerId="ADAL" clId="{E8281CD4-2781-4627-B7F8-2E06C55C46EF}" dt="2021-03-03T04:36:46.580" v="212" actId="1076"/>
        <pc:sldMkLst>
          <pc:docMk/>
          <pc:sldMk cId="3141973803" sldId="284"/>
        </pc:sldMkLst>
        <pc:spChg chg="mod">
          <ac:chgData name="Eugenia Radulescu" userId="4c9b83b1-7b32-4c3b-a428-4cd3c8658a54" providerId="ADAL" clId="{E8281CD4-2781-4627-B7F8-2E06C55C46EF}" dt="2021-03-03T04:36:40.721" v="211"/>
          <ac:spMkLst>
            <pc:docMk/>
            <pc:sldMk cId="3141973803" sldId="284"/>
            <ac:spMk id="18" creationId="{B0CB1DC6-85AE-42F4-99BC-B32CA7F61623}"/>
          </ac:spMkLst>
        </pc:spChg>
        <pc:grpChg chg="add mod">
          <ac:chgData name="Eugenia Radulescu" userId="4c9b83b1-7b32-4c3b-a428-4cd3c8658a54" providerId="ADAL" clId="{E8281CD4-2781-4627-B7F8-2E06C55C46EF}" dt="2021-03-03T04:36:46.580" v="212" actId="1076"/>
          <ac:grpSpMkLst>
            <pc:docMk/>
            <pc:sldMk cId="3141973803" sldId="284"/>
            <ac:grpSpMk id="16" creationId="{9EF301AC-C1B6-4911-A082-0FB7EE8A34A7}"/>
          </ac:grpSpMkLst>
        </pc:grpChg>
        <pc:picChg chg="mod">
          <ac:chgData name="Eugenia Radulescu" userId="4c9b83b1-7b32-4c3b-a428-4cd3c8658a54" providerId="ADAL" clId="{E8281CD4-2781-4627-B7F8-2E06C55C46EF}" dt="2021-03-03T04:36:40.721" v="211"/>
          <ac:picMkLst>
            <pc:docMk/>
            <pc:sldMk cId="3141973803" sldId="284"/>
            <ac:picMk id="17" creationId="{1F248DE5-D8BB-4205-9C3A-6F8128D3021A}"/>
          </ac:picMkLst>
        </pc:picChg>
      </pc:sldChg>
      <pc:sldChg chg="addSp delSp modSp mod">
        <pc:chgData name="Eugenia Radulescu" userId="4c9b83b1-7b32-4c3b-a428-4cd3c8658a54" providerId="ADAL" clId="{E8281CD4-2781-4627-B7F8-2E06C55C46EF}" dt="2021-03-16T13:03:48.861" v="1003" actId="1038"/>
        <pc:sldMkLst>
          <pc:docMk/>
          <pc:sldMk cId="1439316049" sldId="285"/>
        </pc:sldMkLst>
        <pc:spChg chg="add del mod">
          <ac:chgData name="Eugenia Radulescu" userId="4c9b83b1-7b32-4c3b-a428-4cd3c8658a54" providerId="ADAL" clId="{E8281CD4-2781-4627-B7F8-2E06C55C46EF}" dt="2021-03-16T12:58:54.499" v="972" actId="478"/>
          <ac:spMkLst>
            <pc:docMk/>
            <pc:sldMk cId="1439316049" sldId="285"/>
            <ac:spMk id="13" creationId="{66B957FA-DEEC-4943-B86B-5C71338EE842}"/>
          </ac:spMkLst>
        </pc:spChg>
        <pc:spChg chg="mod">
          <ac:chgData name="Eugenia Radulescu" userId="4c9b83b1-7b32-4c3b-a428-4cd3c8658a54" providerId="ADAL" clId="{E8281CD4-2781-4627-B7F8-2E06C55C46EF}" dt="2021-03-16T13:00:28.366" v="993" actId="20577"/>
          <ac:spMkLst>
            <pc:docMk/>
            <pc:sldMk cId="1439316049" sldId="285"/>
            <ac:spMk id="34" creationId="{00000000-0000-0000-0000-000000000000}"/>
          </ac:spMkLst>
        </pc:spChg>
        <pc:spChg chg="mod">
          <ac:chgData name="Eugenia Radulescu" userId="4c9b83b1-7b32-4c3b-a428-4cd3c8658a54" providerId="ADAL" clId="{E8281CD4-2781-4627-B7F8-2E06C55C46EF}" dt="2021-03-16T12:59:45.262" v="975" actId="555"/>
          <ac:spMkLst>
            <pc:docMk/>
            <pc:sldMk cId="1439316049" sldId="285"/>
            <ac:spMk id="35" creationId="{00000000-0000-0000-0000-000000000000}"/>
          </ac:spMkLst>
        </pc:spChg>
        <pc:grpChg chg="mod">
          <ac:chgData name="Eugenia Radulescu" userId="4c9b83b1-7b32-4c3b-a428-4cd3c8658a54" providerId="ADAL" clId="{E8281CD4-2781-4627-B7F8-2E06C55C46EF}" dt="2021-03-16T13:03:48.861" v="1003" actId="1038"/>
          <ac:grpSpMkLst>
            <pc:docMk/>
            <pc:sldMk cId="1439316049" sldId="285"/>
            <ac:grpSpMk id="33" creationId="{00000000-0000-0000-0000-000000000000}"/>
          </ac:grpSpMkLst>
        </pc:grpChg>
      </pc:sldChg>
      <pc:sldChg chg="modSp mod">
        <pc:chgData name="Eugenia Radulescu" userId="4c9b83b1-7b32-4c3b-a428-4cd3c8658a54" providerId="ADAL" clId="{E8281CD4-2781-4627-B7F8-2E06C55C46EF}" dt="2021-03-16T12:15:39.371" v="759" actId="14100"/>
        <pc:sldMkLst>
          <pc:docMk/>
          <pc:sldMk cId="3760301542" sldId="287"/>
        </pc:sldMkLst>
        <pc:picChg chg="mod">
          <ac:chgData name="Eugenia Radulescu" userId="4c9b83b1-7b32-4c3b-a428-4cd3c8658a54" providerId="ADAL" clId="{E8281CD4-2781-4627-B7F8-2E06C55C46EF}" dt="2021-03-16T12:15:39.371" v="759" actId="14100"/>
          <ac:picMkLst>
            <pc:docMk/>
            <pc:sldMk cId="3760301542" sldId="287"/>
            <ac:picMk id="4" creationId="{00000000-0000-0000-0000-000000000000}"/>
          </ac:picMkLst>
        </pc:picChg>
      </pc:sldChg>
      <pc:sldChg chg="addSp modSp mod">
        <pc:chgData name="Eugenia Radulescu" userId="4c9b83b1-7b32-4c3b-a428-4cd3c8658a54" providerId="ADAL" clId="{E8281CD4-2781-4627-B7F8-2E06C55C46EF}" dt="2021-03-16T12:17:51.804" v="844" actId="1035"/>
        <pc:sldMkLst>
          <pc:docMk/>
          <pc:sldMk cId="2781109396" sldId="289"/>
        </pc:sldMkLst>
        <pc:picChg chg="add mod">
          <ac:chgData name="Eugenia Radulescu" userId="4c9b83b1-7b32-4c3b-a428-4cd3c8658a54" providerId="ADAL" clId="{E8281CD4-2781-4627-B7F8-2E06C55C46EF}" dt="2021-03-16T12:17:38.845" v="821" actId="1036"/>
          <ac:picMkLst>
            <pc:docMk/>
            <pc:sldMk cId="2781109396" sldId="289"/>
            <ac:picMk id="61" creationId="{354DB692-1673-4431-9D67-D820685F63A1}"/>
          </ac:picMkLst>
        </pc:picChg>
        <pc:picChg chg="add mod">
          <ac:chgData name="Eugenia Radulescu" userId="4c9b83b1-7b32-4c3b-a428-4cd3c8658a54" providerId="ADAL" clId="{E8281CD4-2781-4627-B7F8-2E06C55C46EF}" dt="2021-03-16T12:17:42.940" v="827" actId="1035"/>
          <ac:picMkLst>
            <pc:docMk/>
            <pc:sldMk cId="2781109396" sldId="289"/>
            <ac:picMk id="62" creationId="{4199D945-C559-41C4-9A4E-FB306ADE2993}"/>
          </ac:picMkLst>
        </pc:picChg>
        <pc:picChg chg="add mod">
          <ac:chgData name="Eugenia Radulescu" userId="4c9b83b1-7b32-4c3b-a428-4cd3c8658a54" providerId="ADAL" clId="{E8281CD4-2781-4627-B7F8-2E06C55C46EF}" dt="2021-03-16T12:17:48.404" v="840" actId="1035"/>
          <ac:picMkLst>
            <pc:docMk/>
            <pc:sldMk cId="2781109396" sldId="289"/>
            <ac:picMk id="63" creationId="{486553E3-45E8-41F7-B1F6-00E0DE85BA9D}"/>
          </ac:picMkLst>
        </pc:picChg>
        <pc:picChg chg="add mod">
          <ac:chgData name="Eugenia Radulescu" userId="4c9b83b1-7b32-4c3b-a428-4cd3c8658a54" providerId="ADAL" clId="{E8281CD4-2781-4627-B7F8-2E06C55C46EF}" dt="2021-03-16T12:17:51.804" v="844" actId="1035"/>
          <ac:picMkLst>
            <pc:docMk/>
            <pc:sldMk cId="2781109396" sldId="289"/>
            <ac:picMk id="64" creationId="{036DE635-865F-4439-868D-68C940DF4211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AC2B5A-ED05-432B-8F77-8FA591338C3A}" type="datetimeFigureOut">
              <a:rPr lang="en-US" smtClean="0"/>
              <a:t>4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9E411B-358B-42C6-BF98-2AF66ACF1C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44076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AC2B5A-ED05-432B-8F77-8FA591338C3A}" type="datetimeFigureOut">
              <a:rPr lang="en-US" smtClean="0"/>
              <a:t>4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9E411B-358B-42C6-BF98-2AF66ACF1C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13765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AC2B5A-ED05-432B-8F77-8FA591338C3A}" type="datetimeFigureOut">
              <a:rPr lang="en-US" smtClean="0"/>
              <a:t>4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9E411B-358B-42C6-BF98-2AF66ACF1C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70999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AC2B5A-ED05-432B-8F77-8FA591338C3A}" type="datetimeFigureOut">
              <a:rPr lang="en-US" smtClean="0"/>
              <a:t>4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9E411B-358B-42C6-BF98-2AF66ACF1C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08662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AC2B5A-ED05-432B-8F77-8FA591338C3A}" type="datetimeFigureOut">
              <a:rPr lang="en-US" smtClean="0"/>
              <a:t>4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9E411B-358B-42C6-BF98-2AF66ACF1C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23366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AC2B5A-ED05-432B-8F77-8FA591338C3A}" type="datetimeFigureOut">
              <a:rPr lang="en-US" smtClean="0"/>
              <a:t>4/2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9E411B-358B-42C6-BF98-2AF66ACF1C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4722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AC2B5A-ED05-432B-8F77-8FA591338C3A}" type="datetimeFigureOut">
              <a:rPr lang="en-US" smtClean="0"/>
              <a:t>4/27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9E411B-358B-42C6-BF98-2AF66ACF1C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32603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AC2B5A-ED05-432B-8F77-8FA591338C3A}" type="datetimeFigureOut">
              <a:rPr lang="en-US" smtClean="0"/>
              <a:t>4/27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9E411B-358B-42C6-BF98-2AF66ACF1C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57571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AC2B5A-ED05-432B-8F77-8FA591338C3A}" type="datetimeFigureOut">
              <a:rPr lang="en-US" smtClean="0"/>
              <a:t>4/27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9E411B-358B-42C6-BF98-2AF66ACF1C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01645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AC2B5A-ED05-432B-8F77-8FA591338C3A}" type="datetimeFigureOut">
              <a:rPr lang="en-US" smtClean="0"/>
              <a:t>4/2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9E411B-358B-42C6-BF98-2AF66ACF1C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82376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AC2B5A-ED05-432B-8F77-8FA591338C3A}" type="datetimeFigureOut">
              <a:rPr lang="en-US" smtClean="0"/>
              <a:t>4/2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9E411B-358B-42C6-BF98-2AF66ACF1C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54012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AC2B5A-ED05-432B-8F77-8FA591338C3A}" type="datetimeFigureOut">
              <a:rPr lang="en-US" smtClean="0"/>
              <a:t>4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9E411B-358B-42C6-BF98-2AF66ACF1C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51388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19200" y="2027238"/>
            <a:ext cx="9948334" cy="1655762"/>
          </a:xfrm>
        </p:spPr>
        <p:txBody>
          <a:bodyPr anchor="ctr"/>
          <a:lstStyle/>
          <a:p>
            <a:r>
              <a:rPr lang="en-US" dirty="0" smtClean="0">
                <a:solidFill>
                  <a:srgbClr val="00B0F0"/>
                </a:solidFill>
              </a:rPr>
              <a:t>“</a:t>
            </a:r>
            <a:r>
              <a:rPr lang="en-US" b="1" dirty="0">
                <a:solidFill>
                  <a:srgbClr val="00B0F0"/>
                </a:solidFill>
              </a:rPr>
              <a:t>Investigating trait variability of gene co-expression network architecture in brain by manipulating genomic signatures of schizophrenia risk”</a:t>
            </a:r>
            <a:endParaRPr lang="en-US" dirty="0">
              <a:solidFill>
                <a:srgbClr val="00B0F0"/>
              </a:solidFill>
            </a:endParaRPr>
          </a:p>
          <a:p>
            <a:endParaRPr lang="en-US" dirty="0">
              <a:solidFill>
                <a:srgbClr val="00B0F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725422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Content Placeholder 5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4947" y="1526902"/>
            <a:ext cx="5801784" cy="4351338"/>
          </a:xfrm>
        </p:spPr>
      </p:pic>
      <p:sp>
        <p:nvSpPr>
          <p:cNvPr id="5" name="Title 1"/>
          <p:cNvSpPr>
            <a:spLocks noGrp="1"/>
          </p:cNvSpPr>
          <p:nvPr>
            <p:ph type="title"/>
          </p:nvPr>
        </p:nvSpPr>
        <p:spPr>
          <a:xfrm>
            <a:off x="838200" y="178857"/>
            <a:ext cx="10515600" cy="1325563"/>
          </a:xfrm>
        </p:spPr>
        <p:txBody>
          <a:bodyPr>
            <a:normAutofit fontScale="90000"/>
          </a:bodyPr>
          <a:lstStyle/>
          <a:p>
            <a:pPr marL="457200" indent="-457200">
              <a:buFont typeface="+mj-lt"/>
              <a:buAutoNum type="arabicPeriod" startAt="2"/>
            </a:pPr>
            <a:r>
              <a:rPr lang="en-US" sz="2400" b="1" dirty="0">
                <a:solidFill>
                  <a:srgbClr val="0070C0"/>
                </a:solidFill>
              </a:rPr>
              <a:t>Characterization of gene expression variance profiles converging from multifactorial effects on DLPFC transcriptome within the two data sets/ groups (LIBD, CMC).</a:t>
            </a:r>
            <a:br>
              <a:rPr lang="en-US" sz="2400" b="1" dirty="0">
                <a:solidFill>
                  <a:srgbClr val="0070C0"/>
                </a:solidFill>
              </a:rPr>
            </a:br>
            <a:endParaRPr lang="en-US" sz="2400" b="1" dirty="0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56859" y="1526902"/>
            <a:ext cx="5799666" cy="4349749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2040463" y="1147225"/>
            <a:ext cx="22243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C00000"/>
                </a:solidFill>
              </a:rPr>
              <a:t>LIBD; n=18,980 genes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8325597" y="1147225"/>
            <a:ext cx="22356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C00000"/>
                </a:solidFill>
              </a:rPr>
              <a:t>CMC; n=27,805 genes</a:t>
            </a:r>
          </a:p>
        </p:txBody>
      </p:sp>
      <p:grpSp>
        <p:nvGrpSpPr>
          <p:cNvPr id="15" name="Group 14"/>
          <p:cNvGrpSpPr/>
          <p:nvPr/>
        </p:nvGrpSpPr>
        <p:grpSpPr>
          <a:xfrm>
            <a:off x="217695" y="5599019"/>
            <a:ext cx="8639924" cy="258062"/>
            <a:chOff x="234947" y="6092157"/>
            <a:chExt cx="8639924" cy="258062"/>
          </a:xfrm>
        </p:grpSpPr>
        <p:cxnSp>
          <p:nvCxnSpPr>
            <p:cNvPr id="11" name="Straight Arrow Connector 10"/>
            <p:cNvCxnSpPr/>
            <p:nvPr/>
          </p:nvCxnSpPr>
          <p:spPr>
            <a:xfrm flipV="1">
              <a:off x="234947" y="6112933"/>
              <a:ext cx="332320" cy="230978"/>
            </a:xfrm>
            <a:prstGeom prst="straightConnector1">
              <a:avLst/>
            </a:prstGeom>
            <a:ln w="127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Arrow Connector 11"/>
            <p:cNvCxnSpPr/>
            <p:nvPr/>
          </p:nvCxnSpPr>
          <p:spPr>
            <a:xfrm flipV="1">
              <a:off x="6322481" y="6112933"/>
              <a:ext cx="332320" cy="230978"/>
            </a:xfrm>
            <a:prstGeom prst="straightConnector1">
              <a:avLst/>
            </a:prstGeom>
            <a:ln w="127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Straight Arrow Connector 12"/>
            <p:cNvCxnSpPr/>
            <p:nvPr/>
          </p:nvCxnSpPr>
          <p:spPr>
            <a:xfrm flipV="1">
              <a:off x="2136283" y="6092157"/>
              <a:ext cx="332320" cy="230978"/>
            </a:xfrm>
            <a:prstGeom prst="straightConnector1">
              <a:avLst/>
            </a:prstGeom>
            <a:ln w="127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Arrow Connector 13"/>
            <p:cNvCxnSpPr/>
            <p:nvPr/>
          </p:nvCxnSpPr>
          <p:spPr>
            <a:xfrm flipV="1">
              <a:off x="8542551" y="6119241"/>
              <a:ext cx="332320" cy="230978"/>
            </a:xfrm>
            <a:prstGeom prst="straightConnector1">
              <a:avLst/>
            </a:prstGeom>
            <a:ln w="127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6" name="TextBox 15"/>
          <p:cNvSpPr txBox="1"/>
          <p:nvPr/>
        </p:nvSpPr>
        <p:spPr>
          <a:xfrm>
            <a:off x="764157" y="6099528"/>
            <a:ext cx="1066368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200" dirty="0">
                <a:solidFill>
                  <a:srgbClr val="002060"/>
                </a:solidFill>
              </a:rPr>
              <a:t>While the overall pattern of variance partition is similar between LIBD and CMC, there are also differences (i.e., in the contribution of technical parameters- total assigned genes, or cell type proportion, etc. Importantly, in the two data sets, variance explained by genomic scores were: </a:t>
            </a:r>
            <a:r>
              <a:rPr lang="en-US" sz="1200" b="1" dirty="0">
                <a:solidFill>
                  <a:srgbClr val="C00000"/>
                </a:solidFill>
              </a:rPr>
              <a:t>LIBD</a:t>
            </a:r>
            <a:r>
              <a:rPr lang="en-US" sz="1200" dirty="0">
                <a:solidFill>
                  <a:srgbClr val="002060"/>
                </a:solidFill>
              </a:rPr>
              <a:t>- median GRS6 SCZ = 0.59% (max = 26.6%), median GS6 </a:t>
            </a:r>
            <a:r>
              <a:rPr lang="en-US" sz="1200" dirty="0" err="1">
                <a:solidFill>
                  <a:srgbClr val="002060"/>
                </a:solidFill>
              </a:rPr>
              <a:t>Ht</a:t>
            </a:r>
            <a:r>
              <a:rPr lang="en-US" sz="1200" dirty="0">
                <a:solidFill>
                  <a:srgbClr val="002060"/>
                </a:solidFill>
              </a:rPr>
              <a:t> = 0.32% (max = 12.6%); </a:t>
            </a:r>
            <a:r>
              <a:rPr lang="en-US" sz="1200" b="1" dirty="0">
                <a:solidFill>
                  <a:srgbClr val="C00000"/>
                </a:solidFill>
              </a:rPr>
              <a:t>CMC</a:t>
            </a:r>
            <a:r>
              <a:rPr lang="en-US" sz="1200" dirty="0">
                <a:solidFill>
                  <a:srgbClr val="002060"/>
                </a:solidFill>
              </a:rPr>
              <a:t>- median GRS6 SCZ = 0.45% (max = 11.4%), median GS6 </a:t>
            </a:r>
            <a:r>
              <a:rPr lang="en-US" sz="1200" dirty="0" err="1">
                <a:solidFill>
                  <a:srgbClr val="002060"/>
                </a:solidFill>
              </a:rPr>
              <a:t>Ht</a:t>
            </a:r>
            <a:r>
              <a:rPr lang="en-US" sz="1200" dirty="0">
                <a:solidFill>
                  <a:srgbClr val="002060"/>
                </a:solidFill>
              </a:rPr>
              <a:t> = 0.46% (max = 13.4%)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67750" y="9524"/>
            <a:ext cx="23836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figure 1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2661558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6643" y="489014"/>
            <a:ext cx="5014358" cy="3340792"/>
          </a:xfrm>
          <a:prstGeom prst="rect">
            <a:avLst/>
          </a:prstGeom>
        </p:spPr>
      </p:pic>
      <p:pic>
        <p:nvPicPr>
          <p:cNvPr id="8" name="Content Placeholder 7"/>
          <p:cNvPicPr>
            <a:picLocks noGrp="1" noChangeAspect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69469" y="489014"/>
            <a:ext cx="5096465" cy="3395496"/>
          </a:xfrm>
        </p:spPr>
      </p:pic>
      <p:grpSp>
        <p:nvGrpSpPr>
          <p:cNvPr id="10" name="Group 9"/>
          <p:cNvGrpSpPr/>
          <p:nvPr/>
        </p:nvGrpSpPr>
        <p:grpSpPr>
          <a:xfrm>
            <a:off x="778912" y="595679"/>
            <a:ext cx="6309845" cy="386268"/>
            <a:chOff x="787380" y="2243663"/>
            <a:chExt cx="6309845" cy="386268"/>
          </a:xfrm>
        </p:grpSpPr>
        <p:sp>
          <p:nvSpPr>
            <p:cNvPr id="5" name="TextBox 4"/>
            <p:cNvSpPr txBox="1"/>
            <p:nvPr/>
          </p:nvSpPr>
          <p:spPr>
            <a:xfrm>
              <a:off x="6468527" y="2243663"/>
              <a:ext cx="6286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solidFill>
                    <a:srgbClr val="C00000"/>
                  </a:solidFill>
                </a:rPr>
                <a:t>CMC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787380" y="2260599"/>
              <a:ext cx="61908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solidFill>
                    <a:srgbClr val="C00000"/>
                  </a:solidFill>
                </a:rPr>
                <a:t>LIBD</a:t>
              </a:r>
            </a:p>
          </p:txBody>
        </p:sp>
      </p:grpSp>
      <p:sp>
        <p:nvSpPr>
          <p:cNvPr id="13" name="TextBox 12"/>
          <p:cNvSpPr txBox="1"/>
          <p:nvPr/>
        </p:nvSpPr>
        <p:spPr>
          <a:xfrm>
            <a:off x="67750" y="9524"/>
            <a:ext cx="23836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figure 2</a:t>
            </a:r>
            <a:endParaRPr lang="en-US" dirty="0"/>
          </a:p>
        </p:txBody>
      </p:sp>
      <p:pic>
        <p:nvPicPr>
          <p:cNvPr id="14" name="Content Placeholder 4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354" t="12970" r="16525" b="7643"/>
          <a:stretch/>
        </p:blipFill>
        <p:spPr>
          <a:xfrm>
            <a:off x="1154133" y="3828403"/>
            <a:ext cx="3599378" cy="2978795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668" t="17156" r="15889" b="9612"/>
          <a:stretch/>
        </p:blipFill>
        <p:spPr>
          <a:xfrm>
            <a:off x="6396915" y="3865626"/>
            <a:ext cx="3767433" cy="29437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617471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/>
          <p:cNvSpPr txBox="1">
            <a:spLocks/>
          </p:cNvSpPr>
          <p:nvPr/>
        </p:nvSpPr>
        <p:spPr>
          <a:xfrm>
            <a:off x="550333" y="466717"/>
            <a:ext cx="11167533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457200" indent="-457200">
              <a:buFont typeface="+mj-lt"/>
              <a:buAutoNum type="arabicPeriod" startAt="3"/>
            </a:pPr>
            <a:r>
              <a:rPr lang="en-US" sz="1800" b="1" dirty="0">
                <a:solidFill>
                  <a:srgbClr val="0070C0"/>
                </a:solidFill>
              </a:rPr>
              <a:t>Group specific WGCNA on four expression data sets resulting from “cleaning” procedures that “protect” or “remove” effects of genomic profiles on gene </a:t>
            </a:r>
            <a:r>
              <a:rPr lang="en-US" sz="1800" b="1" dirty="0" smtClean="0">
                <a:solidFill>
                  <a:srgbClr val="0070C0"/>
                </a:solidFill>
              </a:rPr>
              <a:t>expression</a:t>
            </a:r>
            <a:r>
              <a:rPr lang="en-US" sz="1800" b="1" dirty="0">
                <a:solidFill>
                  <a:srgbClr val="0070C0"/>
                </a:solidFill>
              </a:rPr>
              <a:t/>
            </a:r>
            <a:br>
              <a:rPr lang="en-US" sz="1800" b="1" dirty="0">
                <a:solidFill>
                  <a:srgbClr val="0070C0"/>
                </a:solidFill>
              </a:rPr>
            </a:br>
            <a:endParaRPr lang="en-US" sz="1800" b="1" dirty="0"/>
          </a:p>
        </p:txBody>
      </p:sp>
      <p:grpSp>
        <p:nvGrpSpPr>
          <p:cNvPr id="16" name="Group 15"/>
          <p:cNvGrpSpPr/>
          <p:nvPr/>
        </p:nvGrpSpPr>
        <p:grpSpPr>
          <a:xfrm>
            <a:off x="6005758" y="1725621"/>
            <a:ext cx="6050681" cy="4154997"/>
            <a:chOff x="6005758" y="1556289"/>
            <a:chExt cx="6050681" cy="4154997"/>
          </a:xfrm>
        </p:grpSpPr>
        <p:grpSp>
          <p:nvGrpSpPr>
            <p:cNvPr id="7" name="Group 6"/>
            <p:cNvGrpSpPr/>
            <p:nvPr/>
          </p:nvGrpSpPr>
          <p:grpSpPr>
            <a:xfrm>
              <a:off x="6005758" y="1725696"/>
              <a:ext cx="6050681" cy="3985590"/>
              <a:chOff x="5773331" y="2191372"/>
              <a:chExt cx="6050681" cy="3985590"/>
            </a:xfrm>
          </p:grpSpPr>
          <p:pic>
            <p:nvPicPr>
              <p:cNvPr id="5" name="Picture 4"/>
              <p:cNvPicPr>
                <a:picLocks noChangeAspect="1"/>
              </p:cNvPicPr>
              <p:nvPr/>
            </p:nvPicPr>
            <p:blipFill rotWithShape="1">
              <a:blip r:embed="rId2"/>
              <a:srcRect r="2066"/>
              <a:stretch/>
            </p:blipFill>
            <p:spPr>
              <a:xfrm>
                <a:off x="6049840" y="2191372"/>
                <a:ext cx="5774172" cy="3985590"/>
              </a:xfrm>
              <a:prstGeom prst="rect">
                <a:avLst/>
              </a:prstGeom>
            </p:spPr>
          </p:pic>
          <p:sp>
            <p:nvSpPr>
              <p:cNvPr id="6" name="TextBox 5"/>
              <p:cNvSpPr txBox="1"/>
              <p:nvPr/>
            </p:nvSpPr>
            <p:spPr>
              <a:xfrm>
                <a:off x="5773331" y="4792135"/>
                <a:ext cx="1101584" cy="26161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>
                    <a:solidFill>
                      <a:srgbClr val="C00000"/>
                    </a:solidFill>
                  </a:rPr>
                  <a:t>GRS6 protected</a:t>
                </a:r>
              </a:p>
            </p:txBody>
          </p:sp>
        </p:grpSp>
        <p:sp>
          <p:nvSpPr>
            <p:cNvPr id="9" name="TextBox 8"/>
            <p:cNvSpPr txBox="1"/>
            <p:nvPr/>
          </p:nvSpPr>
          <p:spPr>
            <a:xfrm>
              <a:off x="6445857" y="1556289"/>
              <a:ext cx="6286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solidFill>
                    <a:srgbClr val="C00000"/>
                  </a:solidFill>
                </a:rPr>
                <a:t>CMC</a:t>
              </a:r>
            </a:p>
          </p:txBody>
        </p:sp>
      </p:grpSp>
      <p:grpSp>
        <p:nvGrpSpPr>
          <p:cNvPr id="15" name="Group 14"/>
          <p:cNvGrpSpPr/>
          <p:nvPr/>
        </p:nvGrpSpPr>
        <p:grpSpPr>
          <a:xfrm>
            <a:off x="28952" y="1774042"/>
            <a:ext cx="5965456" cy="4090447"/>
            <a:chOff x="28952" y="1604710"/>
            <a:chExt cx="5965456" cy="4090447"/>
          </a:xfrm>
        </p:grpSpPr>
        <p:grpSp>
          <p:nvGrpSpPr>
            <p:cNvPr id="13" name="Group 12"/>
            <p:cNvGrpSpPr/>
            <p:nvPr/>
          </p:nvGrpSpPr>
          <p:grpSpPr>
            <a:xfrm>
              <a:off x="28952" y="1804125"/>
              <a:ext cx="5965456" cy="3891032"/>
              <a:chOff x="-64185" y="2269801"/>
              <a:chExt cx="5965456" cy="3891032"/>
            </a:xfrm>
          </p:grpSpPr>
          <p:pic>
            <p:nvPicPr>
              <p:cNvPr id="10" name="Picture 9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224119" y="2269801"/>
                <a:ext cx="5677152" cy="3891032"/>
              </a:xfrm>
              <a:prstGeom prst="rect">
                <a:avLst/>
              </a:prstGeom>
            </p:spPr>
          </p:pic>
          <p:sp>
            <p:nvSpPr>
              <p:cNvPr id="11" name="TextBox 10"/>
              <p:cNvSpPr txBox="1"/>
              <p:nvPr/>
            </p:nvSpPr>
            <p:spPr>
              <a:xfrm>
                <a:off x="-64185" y="4817536"/>
                <a:ext cx="1101584" cy="26161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>
                    <a:solidFill>
                      <a:srgbClr val="C00000"/>
                    </a:solidFill>
                  </a:rPr>
                  <a:t>GRS6 protected</a:t>
                </a:r>
              </a:p>
            </p:txBody>
          </p:sp>
        </p:grpSp>
        <p:sp>
          <p:nvSpPr>
            <p:cNvPr id="12" name="TextBox 11"/>
            <p:cNvSpPr txBox="1"/>
            <p:nvPr/>
          </p:nvSpPr>
          <p:spPr>
            <a:xfrm>
              <a:off x="664414" y="1604710"/>
              <a:ext cx="61908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solidFill>
                    <a:srgbClr val="C00000"/>
                  </a:solidFill>
                </a:rPr>
                <a:t>LIBD</a:t>
              </a:r>
            </a:p>
          </p:txBody>
        </p:sp>
      </p:grpSp>
      <p:sp>
        <p:nvSpPr>
          <p:cNvPr id="14" name="TextBox 13"/>
          <p:cNvSpPr txBox="1"/>
          <p:nvPr/>
        </p:nvSpPr>
        <p:spPr>
          <a:xfrm>
            <a:off x="2412439" y="1487059"/>
            <a:ext cx="690156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600" b="1" dirty="0">
                <a:solidFill>
                  <a:srgbClr val="00B0F0"/>
                </a:solidFill>
              </a:rPr>
              <a:t>Cluster </a:t>
            </a:r>
            <a:r>
              <a:rPr lang="en-US" sz="1600" b="1" dirty="0" err="1">
                <a:solidFill>
                  <a:srgbClr val="00B0F0"/>
                </a:solidFill>
              </a:rPr>
              <a:t>dendrograms</a:t>
            </a:r>
            <a:r>
              <a:rPr lang="en-US" sz="1600" b="1" dirty="0">
                <a:solidFill>
                  <a:srgbClr val="00B0F0"/>
                </a:solidFill>
              </a:rPr>
              <a:t> and modules for the four networks within each group.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67750" y="9524"/>
            <a:ext cx="23836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figure 3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2372224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70940" y="575864"/>
            <a:ext cx="9450119" cy="5706271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67750" y="9524"/>
            <a:ext cx="23836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figure 4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7356627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06" t="1111" r="1733" b="1605"/>
          <a:stretch/>
        </p:blipFill>
        <p:spPr>
          <a:xfrm>
            <a:off x="2683933" y="349244"/>
            <a:ext cx="6485467" cy="6127755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347133" y="254000"/>
            <a:ext cx="23836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figure 5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750171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39F16AC49739804D8F30974C94CB9E1C" ma:contentTypeVersion="9" ma:contentTypeDescription="Create a new document." ma:contentTypeScope="" ma:versionID="01a394e4964921950e2d4472c55e624a">
  <xsd:schema xmlns:xsd="http://www.w3.org/2001/XMLSchema" xmlns:xs="http://www.w3.org/2001/XMLSchema" xmlns:p="http://schemas.microsoft.com/office/2006/metadata/properties" xmlns:ns3="5f515a1f-0ca3-4226-9196-411a7f37be5b" targetNamespace="http://schemas.microsoft.com/office/2006/metadata/properties" ma:root="true" ma:fieldsID="e031cd2d40d21174a7efefc6effeee00" ns3:_="">
    <xsd:import namespace="5f515a1f-0ca3-4226-9196-411a7f37be5b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3:MediaServiceDateTaken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f515a1f-0ca3-4226-9196-411a7f37be5b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OCR" ma:index="1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5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6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75855D58-BF1E-4474-883D-D5B7F1BF725C}">
  <ds:schemaRefs>
    <ds:schemaRef ds:uri="5f515a1f-0ca3-4226-9196-411a7f37be5b"/>
    <ds:schemaRef ds:uri="http://purl.org/dc/terms/"/>
    <ds:schemaRef ds:uri="http://schemas.openxmlformats.org/package/2006/metadata/core-properties"/>
    <ds:schemaRef ds:uri="http://schemas.microsoft.com/office/2006/documentManagement/types"/>
    <ds:schemaRef ds:uri="http://schemas.microsoft.com/office/infopath/2007/PartnerControls"/>
    <ds:schemaRef ds:uri="http://purl.org/dc/elements/1.1/"/>
    <ds:schemaRef ds:uri="http://schemas.microsoft.com/office/2006/metadata/properties"/>
    <ds:schemaRef ds:uri="http://www.w3.org/XML/1998/namespace"/>
    <ds:schemaRef ds:uri="http://purl.org/dc/dcmitype/"/>
  </ds:schemaRefs>
</ds:datastoreItem>
</file>

<file path=customXml/itemProps2.xml><?xml version="1.0" encoding="utf-8"?>
<ds:datastoreItem xmlns:ds="http://schemas.openxmlformats.org/officeDocument/2006/customXml" ds:itemID="{7427542D-535A-4CCA-B916-86791C072251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4FD1DD60-9982-473D-B0E0-56454C8A689C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5f515a1f-0ca3-4226-9196-411a7f37be5b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8941</TotalTime>
  <Words>217</Words>
  <Application>Microsoft Office PowerPoint</Application>
  <PresentationFormat>Widescreen</PresentationFormat>
  <Paragraphs>18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owerPoint Presentation</vt:lpstr>
      <vt:lpstr>Characterization of gene expression variance profiles converging from multifactorial effects on DLPFC transcriptome within the two data sets/ groups (LIBD, CMC). </vt:lpstr>
      <vt:lpstr>PowerPoint Presentation</vt:lpstr>
      <vt:lpstr>PowerPoint Presentation</vt:lpstr>
      <vt:lpstr>PowerPoint Presentation</vt:lpstr>
      <vt:lpstr>PowerPoint Presentation</vt:lpstr>
    </vt:vector>
  </TitlesOfParts>
  <Company>Johns Hopkin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omparison of two independent datasets relative to the effects of GRS6 SCZ on the DLPFC gene co-expression network</dc:title>
  <dc:creator>Eugenia Radulescu</dc:creator>
  <cp:lastModifiedBy>Eugenia Radulescu</cp:lastModifiedBy>
  <cp:revision>256</cp:revision>
  <dcterms:created xsi:type="dcterms:W3CDTF">2021-01-29T15:54:13Z</dcterms:created>
  <dcterms:modified xsi:type="dcterms:W3CDTF">2021-04-28T00:04:1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39F16AC49739804D8F30974C94CB9E1C</vt:lpwstr>
  </property>
</Properties>
</file>